
<file path=[Content_Types].xml><?xml version="1.0" encoding="utf-8"?>
<Types xmlns="http://schemas.openxmlformats.org/package/2006/content-types">
  <Default Extension="bin" ContentType="application/vnd.openxmlformats-officedocument.presentationml.printerSettings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0" d="100"/>
          <a:sy n="80" d="100"/>
        </p:scale>
        <p:origin x="-1824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printerSettings" Target="printerSettings/printerSettings1.bin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5" Type="http://schemas.openxmlformats.org/officeDocument/2006/relationships/viewProps" Target="viewProps.xml"/><Relationship Id="rId10" Type="http://schemas.openxmlformats.org/officeDocument/2006/relationships/customXml" Target="../customXml/item3.xml"/><Relationship Id="rId4" Type="http://schemas.openxmlformats.org/officeDocument/2006/relationships/presProps" Target="presProps.xml"/><Relationship Id="rId9" Type="http://schemas.openxmlformats.org/officeDocument/2006/relationships/customXml" Target="../customXml/item2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mystuff:Desktop:PhD%20master%20collection:Projects:WI38:Story%202%20-%20Human%20senescence%20and%20X-ray:qPCRs:X-ray%20qPCRs%20result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mystuff:Desktop:PhD%20master%20collection:Projects:WI38:Story%202%20-%20Human%20senescence%20and%20X-ray:qPCRs:X-ray%20qPCRs%20result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D$61:$D$69</c:f>
                <c:numCache>
                  <c:formatCode>General</c:formatCode>
                  <c:ptCount val="9"/>
                  <c:pt idx="0">
                    <c:v>0.0415623388551596</c:v>
                  </c:pt>
                  <c:pt idx="1">
                    <c:v>0.0241953792650121</c:v>
                  </c:pt>
                  <c:pt idx="2">
                    <c:v>0.0504430420265163</c:v>
                  </c:pt>
                  <c:pt idx="3">
                    <c:v>0.0523569229212124</c:v>
                  </c:pt>
                  <c:pt idx="4">
                    <c:v>0.015258287365669</c:v>
                  </c:pt>
                  <c:pt idx="5">
                    <c:v>0.0358080669061534</c:v>
                  </c:pt>
                  <c:pt idx="6">
                    <c:v>0.0165891296402862</c:v>
                  </c:pt>
                  <c:pt idx="7">
                    <c:v>0.0288395224571343</c:v>
                  </c:pt>
                  <c:pt idx="8">
                    <c:v>0.0356258043184057</c:v>
                  </c:pt>
                </c:numCache>
              </c:numRef>
            </c:plus>
            <c:minus>
              <c:numRef>
                <c:f>Sheet1!$D$61:$D$69</c:f>
                <c:numCache>
                  <c:formatCode>General</c:formatCode>
                  <c:ptCount val="9"/>
                  <c:pt idx="0">
                    <c:v>0.0415623388551596</c:v>
                  </c:pt>
                  <c:pt idx="1">
                    <c:v>0.0241953792650121</c:v>
                  </c:pt>
                  <c:pt idx="2">
                    <c:v>0.0504430420265163</c:v>
                  </c:pt>
                  <c:pt idx="3">
                    <c:v>0.0523569229212124</c:v>
                  </c:pt>
                  <c:pt idx="4">
                    <c:v>0.015258287365669</c:v>
                  </c:pt>
                  <c:pt idx="5">
                    <c:v>0.0358080669061534</c:v>
                  </c:pt>
                  <c:pt idx="6">
                    <c:v>0.0165891296402862</c:v>
                  </c:pt>
                  <c:pt idx="7">
                    <c:v>0.0288395224571343</c:v>
                  </c:pt>
                  <c:pt idx="8">
                    <c:v>0.0356258043184057</c:v>
                  </c:pt>
                </c:numCache>
              </c:numRef>
            </c:minus>
          </c:errBars>
          <c:cat>
            <c:multiLvlStrRef>
              <c:f>Sheet1!$A$61:$B$69</c:f>
              <c:multiLvlStrCache>
                <c:ptCount val="9"/>
                <c:lvl>
                  <c:pt idx="0">
                    <c:v>0 Gy</c:v>
                  </c:pt>
                  <c:pt idx="1">
                    <c:v>0.5 Gy</c:v>
                  </c:pt>
                  <c:pt idx="2">
                    <c:v>5 Gy</c:v>
                  </c:pt>
                  <c:pt idx="3">
                    <c:v>0 Gy</c:v>
                  </c:pt>
                  <c:pt idx="4">
                    <c:v>0.5 Gy</c:v>
                  </c:pt>
                  <c:pt idx="5">
                    <c:v>5 Gy</c:v>
                  </c:pt>
                  <c:pt idx="6">
                    <c:v>0 Gy</c:v>
                  </c:pt>
                  <c:pt idx="7">
                    <c:v>0.5 Gy</c:v>
                  </c:pt>
                  <c:pt idx="8">
                    <c:v>5 Gy</c:v>
                  </c:pt>
                </c:lvl>
                <c:lvl>
                  <c:pt idx="0">
                    <c:v>PD 38</c:v>
                  </c:pt>
                  <c:pt idx="3">
                    <c:v>PD 47</c:v>
                  </c:pt>
                  <c:pt idx="6">
                    <c:v>PD 54</c:v>
                  </c:pt>
                </c:lvl>
              </c:multiLvlStrCache>
            </c:multiLvlStrRef>
          </c:cat>
          <c:val>
            <c:numRef>
              <c:f>Sheet1!$C$61:$C$69</c:f>
              <c:numCache>
                <c:formatCode>0.000</c:formatCode>
                <c:ptCount val="9"/>
                <c:pt idx="0">
                  <c:v>1.015433333333333</c:v>
                </c:pt>
                <c:pt idx="1">
                  <c:v>0.991666666666667</c:v>
                </c:pt>
                <c:pt idx="2">
                  <c:v>1.0263</c:v>
                </c:pt>
                <c:pt idx="3">
                  <c:v>0.7236</c:v>
                </c:pt>
                <c:pt idx="4">
                  <c:v>0.759233333333333</c:v>
                </c:pt>
                <c:pt idx="5">
                  <c:v>0.911533333333333</c:v>
                </c:pt>
                <c:pt idx="6">
                  <c:v>0.4983</c:v>
                </c:pt>
                <c:pt idx="7">
                  <c:v>0.711566666666667</c:v>
                </c:pt>
                <c:pt idx="8">
                  <c:v>1.08626666666666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67936712"/>
        <c:axId val="-2046634744"/>
      </c:barChart>
      <c:catAx>
        <c:axId val="-2067936712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-2046634744"/>
        <c:crosses val="autoZero"/>
        <c:auto val="1"/>
        <c:lblAlgn val="ctr"/>
        <c:lblOffset val="100"/>
        <c:noMultiLvlLbl val="0"/>
      </c:catAx>
      <c:valAx>
        <c:axId val="-2046634744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i="1"/>
                  <a:t>COL3A1</a:t>
                </a:r>
                <a:r>
                  <a:rPr lang="en-US"/>
                  <a:t> transcript level (A.U.)</a:t>
                </a:r>
              </a:p>
            </c:rich>
          </c:tx>
          <c:layout/>
          <c:overlay val="0"/>
        </c:title>
        <c:numFmt formatCode="0.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-2067936712"/>
        <c:crosses val="autoZero"/>
        <c:crossBetween val="between"/>
      </c:valAx>
      <c:spPr>
        <a:ln>
          <a:noFill/>
        </a:ln>
      </c:spPr>
    </c:plotArea>
    <c:plotVisOnly val="1"/>
    <c:dispBlanksAs val="gap"/>
    <c:showDLblsOverMax val="0"/>
  </c:chart>
  <c:txPr>
    <a:bodyPr/>
    <a:lstStyle/>
    <a:p>
      <a:pPr>
        <a:defRPr sz="1400" b="0"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AD$61:$AD$69</c:f>
                <c:numCache>
                  <c:formatCode>General</c:formatCode>
                  <c:ptCount val="9"/>
                  <c:pt idx="0">
                    <c:v>0.0458106416555028</c:v>
                  </c:pt>
                  <c:pt idx="1">
                    <c:v>0.0257376891822954</c:v>
                  </c:pt>
                  <c:pt idx="2">
                    <c:v>0.0530593978480721</c:v>
                  </c:pt>
                  <c:pt idx="3">
                    <c:v>0.0465627211404145</c:v>
                  </c:pt>
                  <c:pt idx="4">
                    <c:v>0.0254509993255013</c:v>
                  </c:pt>
                  <c:pt idx="5">
                    <c:v>0.0334121183937139</c:v>
                  </c:pt>
                  <c:pt idx="6">
                    <c:v>0.0193142719251853</c:v>
                  </c:pt>
                  <c:pt idx="7">
                    <c:v>0.0363194140004121</c:v>
                  </c:pt>
                  <c:pt idx="8">
                    <c:v>0.0212283034335452</c:v>
                  </c:pt>
                </c:numCache>
              </c:numRef>
            </c:plus>
            <c:minus>
              <c:numRef>
                <c:f>Sheet1!$AD$61:$AD$69</c:f>
                <c:numCache>
                  <c:formatCode>General</c:formatCode>
                  <c:ptCount val="9"/>
                  <c:pt idx="0">
                    <c:v>0.0458106416555028</c:v>
                  </c:pt>
                  <c:pt idx="1">
                    <c:v>0.0257376891822954</c:v>
                  </c:pt>
                  <c:pt idx="2">
                    <c:v>0.0530593978480721</c:v>
                  </c:pt>
                  <c:pt idx="3">
                    <c:v>0.0465627211404145</c:v>
                  </c:pt>
                  <c:pt idx="4">
                    <c:v>0.0254509993255013</c:v>
                  </c:pt>
                  <c:pt idx="5">
                    <c:v>0.0334121183937139</c:v>
                  </c:pt>
                  <c:pt idx="6">
                    <c:v>0.0193142719251853</c:v>
                  </c:pt>
                  <c:pt idx="7">
                    <c:v>0.0363194140004121</c:v>
                  </c:pt>
                  <c:pt idx="8">
                    <c:v>0.0212283034335452</c:v>
                  </c:pt>
                </c:numCache>
              </c:numRef>
            </c:minus>
          </c:errBars>
          <c:cat>
            <c:multiLvlStrRef>
              <c:f>Sheet1!$AA$61:$AB$69</c:f>
              <c:multiLvlStrCache>
                <c:ptCount val="9"/>
                <c:lvl>
                  <c:pt idx="0">
                    <c:v>0 Gy</c:v>
                  </c:pt>
                  <c:pt idx="1">
                    <c:v>0.5 Gy</c:v>
                  </c:pt>
                  <c:pt idx="2">
                    <c:v>5 Gy</c:v>
                  </c:pt>
                  <c:pt idx="3">
                    <c:v>0 Gy</c:v>
                  </c:pt>
                  <c:pt idx="4">
                    <c:v>0.5 Gy</c:v>
                  </c:pt>
                  <c:pt idx="5">
                    <c:v>5 Gy</c:v>
                  </c:pt>
                  <c:pt idx="6">
                    <c:v>0 Gy</c:v>
                  </c:pt>
                  <c:pt idx="7">
                    <c:v>0.5 Gy</c:v>
                  </c:pt>
                  <c:pt idx="8">
                    <c:v>5 Gy</c:v>
                  </c:pt>
                </c:lvl>
                <c:lvl>
                  <c:pt idx="0">
                    <c:v>PD 38</c:v>
                  </c:pt>
                  <c:pt idx="3">
                    <c:v>PD 47</c:v>
                  </c:pt>
                  <c:pt idx="6">
                    <c:v>PD 54</c:v>
                  </c:pt>
                </c:lvl>
              </c:multiLvlStrCache>
            </c:multiLvlStrRef>
          </c:cat>
          <c:val>
            <c:numRef>
              <c:f>Sheet1!$AC$61:$AC$69</c:f>
              <c:numCache>
                <c:formatCode>0.000</c:formatCode>
                <c:ptCount val="9"/>
                <c:pt idx="0">
                  <c:v>1.000533333333333</c:v>
                </c:pt>
                <c:pt idx="1">
                  <c:v>0.9492</c:v>
                </c:pt>
                <c:pt idx="2">
                  <c:v>0.7943</c:v>
                </c:pt>
                <c:pt idx="3">
                  <c:v>0.9282</c:v>
                </c:pt>
                <c:pt idx="4">
                  <c:v>0.901033333333333</c:v>
                </c:pt>
                <c:pt idx="5">
                  <c:v>0.795966666666667</c:v>
                </c:pt>
                <c:pt idx="6">
                  <c:v>0.592933333333333</c:v>
                </c:pt>
                <c:pt idx="7">
                  <c:v>0.559033333333333</c:v>
                </c:pt>
                <c:pt idx="8">
                  <c:v>0.447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48306056"/>
        <c:axId val="-2046711496"/>
      </c:barChart>
      <c:catAx>
        <c:axId val="2048306056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-2046711496"/>
        <c:crosses val="autoZero"/>
        <c:auto val="1"/>
        <c:lblAlgn val="ctr"/>
        <c:lblOffset val="100"/>
        <c:noMultiLvlLbl val="0"/>
      </c:catAx>
      <c:valAx>
        <c:axId val="-2046711496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i="1"/>
                  <a:t>UBE2C</a:t>
                </a:r>
                <a:r>
                  <a:rPr lang="en-US"/>
                  <a:t> transcript level (A.U.)</a:t>
                </a:r>
              </a:p>
            </c:rich>
          </c:tx>
          <c:layout/>
          <c:overlay val="0"/>
        </c:title>
        <c:numFmt formatCode="0.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2048306056"/>
        <c:crosses val="autoZero"/>
        <c:crossBetween val="between"/>
      </c:valAx>
      <c:spPr>
        <a:ln>
          <a:noFill/>
        </a:ln>
      </c:spPr>
    </c:plotArea>
    <c:plotVisOnly val="1"/>
    <c:dispBlanksAs val="gap"/>
    <c:showDLblsOverMax val="0"/>
  </c:chart>
  <c:txPr>
    <a:bodyPr/>
    <a:lstStyle/>
    <a:p>
      <a:pPr>
        <a:defRPr sz="1400" b="0"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CA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F53EE-696C-FE40-BB23-D01F1C1FA4C0}" type="datetimeFigureOut">
              <a:rPr lang="en-US" smtClean="0"/>
              <a:t>2014-07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494E2-F4B1-B447-B534-76ADF9FAFC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99870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F53EE-696C-FE40-BB23-D01F1C1FA4C0}" type="datetimeFigureOut">
              <a:rPr lang="en-US" smtClean="0"/>
              <a:t>2014-07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494E2-F4B1-B447-B534-76ADF9FAFC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63079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F53EE-696C-FE40-BB23-D01F1C1FA4C0}" type="datetimeFigureOut">
              <a:rPr lang="en-US" smtClean="0"/>
              <a:t>2014-07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494E2-F4B1-B447-B534-76ADF9FAFC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93839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F53EE-696C-FE40-BB23-D01F1C1FA4C0}" type="datetimeFigureOut">
              <a:rPr lang="en-US" smtClean="0"/>
              <a:t>2014-07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494E2-F4B1-B447-B534-76ADF9FAFC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87125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F53EE-696C-FE40-BB23-D01F1C1FA4C0}" type="datetimeFigureOut">
              <a:rPr lang="en-US" smtClean="0"/>
              <a:t>2014-07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494E2-F4B1-B447-B534-76ADF9FAFC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73899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F53EE-696C-FE40-BB23-D01F1C1FA4C0}" type="datetimeFigureOut">
              <a:rPr lang="en-US" smtClean="0"/>
              <a:t>2014-07-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494E2-F4B1-B447-B534-76ADF9FAFC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45865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F53EE-696C-FE40-BB23-D01F1C1FA4C0}" type="datetimeFigureOut">
              <a:rPr lang="en-US" smtClean="0"/>
              <a:t>2014-07-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494E2-F4B1-B447-B534-76ADF9FAFC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50295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F53EE-696C-FE40-BB23-D01F1C1FA4C0}" type="datetimeFigureOut">
              <a:rPr lang="en-US" smtClean="0"/>
              <a:t>2014-07-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494E2-F4B1-B447-B534-76ADF9FAFC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06433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F53EE-696C-FE40-BB23-D01F1C1FA4C0}" type="datetimeFigureOut">
              <a:rPr lang="en-US" smtClean="0"/>
              <a:t>2014-07-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494E2-F4B1-B447-B534-76ADF9FAFC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79649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F53EE-696C-FE40-BB23-D01F1C1FA4C0}" type="datetimeFigureOut">
              <a:rPr lang="en-US" smtClean="0"/>
              <a:t>2014-07-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494E2-F4B1-B447-B534-76ADF9FAFC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76767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F53EE-696C-FE40-BB23-D01F1C1FA4C0}" type="datetimeFigureOut">
              <a:rPr lang="en-US" smtClean="0"/>
              <a:t>2014-07-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494E2-F4B1-B447-B534-76ADF9FAFC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69775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3F53EE-696C-FE40-BB23-D01F1C1FA4C0}" type="datetimeFigureOut">
              <a:rPr lang="en-US" smtClean="0"/>
              <a:t>2014-07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6494E2-F4B1-B447-B534-76ADF9FAFC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44946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Relationship Id="rId3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62602602"/>
              </p:ext>
            </p:extLst>
          </p:nvPr>
        </p:nvGraphicFramePr>
        <p:xfrm>
          <a:off x="-98778" y="239889"/>
          <a:ext cx="3167999" cy="31686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89781966"/>
              </p:ext>
            </p:extLst>
          </p:nvPr>
        </p:nvGraphicFramePr>
        <p:xfrm>
          <a:off x="3133186" y="239889"/>
          <a:ext cx="3167999" cy="31686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22" name="Straight Connector 21"/>
          <p:cNvCxnSpPr/>
          <p:nvPr/>
        </p:nvCxnSpPr>
        <p:spPr>
          <a:xfrm>
            <a:off x="4068808" y="425777"/>
            <a:ext cx="1481666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5550474" y="425777"/>
            <a:ext cx="0" cy="827999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>
            <a:off x="4816696" y="564067"/>
            <a:ext cx="719999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>
            <a:off x="4813874" y="564068"/>
            <a:ext cx="0" cy="179997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4700983" y="150242"/>
            <a:ext cx="5362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35" name="TextBox 34"/>
          <p:cNvSpPr txBox="1"/>
          <p:nvPr/>
        </p:nvSpPr>
        <p:spPr>
          <a:xfrm>
            <a:off x="4415938" y="752991"/>
            <a:ext cx="2850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36" name="TextBox 35"/>
          <p:cNvSpPr txBox="1"/>
          <p:nvPr/>
        </p:nvSpPr>
        <p:spPr>
          <a:xfrm>
            <a:off x="5880660" y="1371054"/>
            <a:ext cx="5362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2" name="TextBox 1"/>
          <p:cNvSpPr txBox="1"/>
          <p:nvPr/>
        </p:nvSpPr>
        <p:spPr>
          <a:xfrm>
            <a:off x="0" y="3703963"/>
            <a:ext cx="7257743" cy="17543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b="1" dirty="0" smtClean="0"/>
              <a:t>S5: </a:t>
            </a:r>
            <a:r>
              <a:rPr lang="en-CA" b="1" dirty="0"/>
              <a:t>Senescence-associated gene expression with increasing age and X-ray irradiation dose.</a:t>
            </a:r>
            <a:endParaRPr lang="en-US" dirty="0"/>
          </a:p>
          <a:p>
            <a:r>
              <a:rPr lang="en-CA" dirty="0"/>
              <a:t>Transcriptional levels of </a:t>
            </a:r>
            <a:r>
              <a:rPr lang="en-CA" i="1" dirty="0"/>
              <a:t>UBE2C</a:t>
            </a:r>
            <a:r>
              <a:rPr lang="en-CA" dirty="0"/>
              <a:t>, and </a:t>
            </a:r>
            <a:r>
              <a:rPr lang="en-CA" i="1" dirty="0"/>
              <a:t>COL3A1</a:t>
            </a:r>
            <a:r>
              <a:rPr lang="en-CA" dirty="0"/>
              <a:t>. Averages from three samples and two technical repeats normalized to the expression in the control PD 38 </a:t>
            </a:r>
            <a:r>
              <a:rPr lang="en-CA" dirty="0" smtClean="0"/>
              <a:t>cells, numbers are shown as arbitrary units (A.U.). </a:t>
            </a:r>
            <a:r>
              <a:rPr lang="en-CA" dirty="0"/>
              <a:t>Error bars indicate error progression of SDs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104799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4049BCDEDFDB049B71912F60AEF0606" ma:contentTypeVersion="7" ma:contentTypeDescription="Create a new document." ma:contentTypeScope="" ma:versionID="f60120a373493ec899016d9b0c73f16f">
  <xsd:schema xmlns:xsd="http://www.w3.org/2001/XMLSchema" xmlns:p="http://schemas.microsoft.com/office/2006/metadata/properties" xmlns:ns2="c5f0cf77-8f69-4877-a76d-68bf7c58cccf" targetNamespace="http://schemas.microsoft.com/office/2006/metadata/properties" ma:root="true" ma:fieldsID="19e4a1b7ef6be26a4e554d1c0be7756b" ns2:_="">
    <xsd:import namespace="c5f0cf77-8f69-4877-a76d-68bf7c58cccf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c5f0cf77-8f69-4877-a76d-68bf7c58cccf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TitleName xmlns="c5f0cf77-8f69-4877-a76d-68bf7c58cccf">Presentation 1.PPTX</TitleName>
    <Checked_x0020_Out_x0020_To xmlns="c5f0cf77-8f69-4877-a76d-68bf7c58cccf">
      <UserInfo>
        <DisplayName/>
        <AccountId xsi:nil="true"/>
        <AccountType/>
      </UserInfo>
    </Checked_x0020_Out_x0020_To>
    <IsDeleted xmlns="c5f0cf77-8f69-4877-a76d-68bf7c58cccf">false</IsDeleted>
    <StageName xmlns="c5f0cf77-8f69-4877-a76d-68bf7c58cccf" xsi:nil="true"/>
    <DocumentType xmlns="c5f0cf77-8f69-4877-a76d-68bf7c58cccf">Presentation</DocumentType>
    <FileFormat xmlns="c5f0cf77-8f69-4877-a76d-68bf7c58cccf">PPTX</FileFormat>
    <DocumentId xmlns="c5f0cf77-8f69-4877-a76d-68bf7c58cccf">Presentation 1.PPTX</DocumentId>
  </documentManagement>
</p:properties>
</file>

<file path=customXml/itemProps1.xml><?xml version="1.0" encoding="utf-8"?>
<ds:datastoreItem xmlns:ds="http://schemas.openxmlformats.org/officeDocument/2006/customXml" ds:itemID="{B16DF707-58C8-48C8-ACF6-8E7ACD151AB2}"/>
</file>

<file path=customXml/itemProps2.xml><?xml version="1.0" encoding="utf-8"?>
<ds:datastoreItem xmlns:ds="http://schemas.openxmlformats.org/officeDocument/2006/customXml" ds:itemID="{4941DE20-2E2E-455D-BFAA-FB46C231D164}"/>
</file>

<file path=customXml/itemProps3.xml><?xml version="1.0" encoding="utf-8"?>
<ds:datastoreItem xmlns:ds="http://schemas.openxmlformats.org/officeDocument/2006/customXml" ds:itemID="{B482B7C6-8714-4A2B-B276-DEFDF6AF4788}"/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80</Words>
  <Application>Microsoft Macintosh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rinne</dc:creator>
  <cp:lastModifiedBy>Corinne</cp:lastModifiedBy>
  <cp:revision>5</cp:revision>
  <dcterms:created xsi:type="dcterms:W3CDTF">2013-05-08T15:47:48Z</dcterms:created>
  <dcterms:modified xsi:type="dcterms:W3CDTF">2014-07-18T16:48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4049BCDEDFDB049B71912F60AEF0606</vt:lpwstr>
  </property>
</Properties>
</file>